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8" d="100"/>
          <a:sy n="68" d="100"/>
        </p:scale>
        <p:origin x="144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NO%20NAME:screening%20mol:frequence%20par%20histo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NO%20NAME:screening%20mol:frequence%20par%20histo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NO%20NAME:screening%20mol:frequence%20par%20histo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NO%20NAME:screening%20mol:frequence%20par%20histo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NO%20NAME:screening%20mol:frequence%20par%20histo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NO%20NAME:screening%20mol:frequence%20par%20histo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NO%20NAME:screening%20mol:frequence%20par%20histo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NO%20NAME:screening%20mol:frequence%20par%20histo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NO%20NAME:screening%20mol:frequence%20par%20histo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NO%20NAME:screening%20mol:frequence%20par%20hist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1"/>
        <c:ser>
          <c:idx val="0"/>
          <c:order val="0"/>
          <c:tx>
            <c:strRef>
              <c:f>Feuil1!$B$16</c:f>
              <c:strCache>
                <c:ptCount val="1"/>
                <c:pt idx="0">
                  <c:v>Lung</c:v>
                </c:pt>
              </c:strCache>
            </c:strRef>
          </c:tx>
          <c:invertIfNegative val="0"/>
          <c:cat>
            <c:strRef>
              <c:f>Feuil1!$A$17:$A$26</c:f>
              <c:strCache>
                <c:ptCount val="10"/>
                <c:pt idx="0">
                  <c:v>TP53</c:v>
                </c:pt>
                <c:pt idx="1">
                  <c:v>CDKN2A</c:v>
                </c:pt>
                <c:pt idx="2">
                  <c:v>KRAS</c:v>
                </c:pt>
                <c:pt idx="3">
                  <c:v>PTEN</c:v>
                </c:pt>
                <c:pt idx="4">
                  <c:v>PI3KCA</c:v>
                </c:pt>
                <c:pt idx="5">
                  <c:v>RB1</c:v>
                </c:pt>
                <c:pt idx="6">
                  <c:v>APC</c:v>
                </c:pt>
                <c:pt idx="7">
                  <c:v>ERBB2</c:v>
                </c:pt>
                <c:pt idx="8">
                  <c:v>MYC</c:v>
                </c:pt>
                <c:pt idx="9">
                  <c:v>EGFR</c:v>
                </c:pt>
              </c:strCache>
            </c:strRef>
          </c:cat>
          <c:val>
            <c:numRef>
              <c:f>Feuil1!$B$17:$B$26</c:f>
              <c:numCache>
                <c:formatCode>0.0</c:formatCode>
                <c:ptCount val="10"/>
                <c:pt idx="0">
                  <c:v>49</c:v>
                </c:pt>
                <c:pt idx="1">
                  <c:v>29.2</c:v>
                </c:pt>
                <c:pt idx="2">
                  <c:v>18.8</c:v>
                </c:pt>
                <c:pt idx="3">
                  <c:v>7.3</c:v>
                </c:pt>
                <c:pt idx="4">
                  <c:v>7.3</c:v>
                </c:pt>
                <c:pt idx="5">
                  <c:v>8.3000000000000007</c:v>
                </c:pt>
                <c:pt idx="6">
                  <c:v>2.1</c:v>
                </c:pt>
                <c:pt idx="7">
                  <c:v>7.3</c:v>
                </c:pt>
                <c:pt idx="8">
                  <c:v>8.3000000000000007</c:v>
                </c:pt>
                <c:pt idx="9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265-43A4-B4E6-1B5771A2C3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3197944"/>
        <c:axId val="2093200952"/>
      </c:barChart>
      <c:catAx>
        <c:axId val="20931979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93200952"/>
        <c:crosses val="autoZero"/>
        <c:auto val="1"/>
        <c:lblAlgn val="ctr"/>
        <c:lblOffset val="100"/>
        <c:noMultiLvlLbl val="0"/>
      </c:catAx>
      <c:valAx>
        <c:axId val="2093200952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20931979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Cervical</a:t>
            </a:r>
            <a:endParaRPr lang="en-US" dirty="0"/>
          </a:p>
        </c:rich>
      </c:tx>
      <c:overlay val="0"/>
    </c:title>
    <c:autoTitleDeleted val="0"/>
    <c:plotArea>
      <c:layout/>
      <c:barChart>
        <c:barDir val="col"/>
        <c:grouping val="stacked"/>
        <c:varyColors val="1"/>
        <c:ser>
          <c:idx val="0"/>
          <c:order val="0"/>
          <c:tx>
            <c:strRef>
              <c:f>Feuil1!$B$141</c:f>
              <c:strCache>
                <c:ptCount val="1"/>
                <c:pt idx="0">
                  <c:v>Cervix</c:v>
                </c:pt>
              </c:strCache>
            </c:strRef>
          </c:tx>
          <c:invertIfNegative val="0"/>
          <c:cat>
            <c:strRef>
              <c:f>Feuil1!$A$142:$A$151</c:f>
              <c:strCache>
                <c:ptCount val="10"/>
                <c:pt idx="0">
                  <c:v>TP53</c:v>
                </c:pt>
                <c:pt idx="1">
                  <c:v>CDKN2A</c:v>
                </c:pt>
                <c:pt idx="2">
                  <c:v>KRAS</c:v>
                </c:pt>
                <c:pt idx="3">
                  <c:v>PTEN</c:v>
                </c:pt>
                <c:pt idx="4">
                  <c:v>PI3KCA</c:v>
                </c:pt>
                <c:pt idx="5">
                  <c:v>RB1</c:v>
                </c:pt>
                <c:pt idx="6">
                  <c:v>APC</c:v>
                </c:pt>
                <c:pt idx="7">
                  <c:v>ERBB2</c:v>
                </c:pt>
                <c:pt idx="8">
                  <c:v>MYC</c:v>
                </c:pt>
                <c:pt idx="9">
                  <c:v>EGFR</c:v>
                </c:pt>
              </c:strCache>
            </c:strRef>
          </c:cat>
          <c:val>
            <c:numRef>
              <c:f>Feuil1!$B$142:$B$151</c:f>
              <c:numCache>
                <c:formatCode>0.0</c:formatCode>
                <c:ptCount val="10"/>
                <c:pt idx="0">
                  <c:v>13.3</c:v>
                </c:pt>
                <c:pt idx="1">
                  <c:v>0</c:v>
                </c:pt>
                <c:pt idx="2">
                  <c:v>0</c:v>
                </c:pt>
                <c:pt idx="3">
                  <c:v>13.3</c:v>
                </c:pt>
                <c:pt idx="4">
                  <c:v>13.3</c:v>
                </c:pt>
                <c:pt idx="5">
                  <c:v>6.7</c:v>
                </c:pt>
                <c:pt idx="6">
                  <c:v>0</c:v>
                </c:pt>
                <c:pt idx="7">
                  <c:v>0</c:v>
                </c:pt>
                <c:pt idx="8">
                  <c:v>6.7</c:v>
                </c:pt>
                <c:pt idx="9">
                  <c:v>6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7E-418C-8F06-D43EFD1005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3241688"/>
        <c:axId val="2093244712"/>
      </c:barChart>
      <c:catAx>
        <c:axId val="20932416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93244712"/>
        <c:crosses val="autoZero"/>
        <c:auto val="1"/>
        <c:lblAlgn val="ctr"/>
        <c:lblOffset val="100"/>
        <c:noMultiLvlLbl val="0"/>
      </c:catAx>
      <c:valAx>
        <c:axId val="2093244712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20932416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overlay val="0"/>
    </c:title>
    <c:autoTitleDeleted val="0"/>
    <c:plotArea>
      <c:layout/>
      <c:barChart>
        <c:barDir val="col"/>
        <c:grouping val="stacked"/>
        <c:varyColors val="1"/>
        <c:ser>
          <c:idx val="0"/>
          <c:order val="0"/>
          <c:tx>
            <c:strRef>
              <c:f>Feuil1!$B$28</c:f>
              <c:strCache>
                <c:ptCount val="1"/>
                <c:pt idx="0">
                  <c:v>Colorectal</c:v>
                </c:pt>
              </c:strCache>
            </c:strRef>
          </c:tx>
          <c:invertIfNegative val="0"/>
          <c:cat>
            <c:strRef>
              <c:f>Feuil1!$A$29:$A$38</c:f>
              <c:strCache>
                <c:ptCount val="10"/>
                <c:pt idx="0">
                  <c:v>TP53</c:v>
                </c:pt>
                <c:pt idx="1">
                  <c:v>CDKN2A</c:v>
                </c:pt>
                <c:pt idx="2">
                  <c:v>KRAS</c:v>
                </c:pt>
                <c:pt idx="3">
                  <c:v>PTEN</c:v>
                </c:pt>
                <c:pt idx="4">
                  <c:v>PI3KCA</c:v>
                </c:pt>
                <c:pt idx="5">
                  <c:v>RB1</c:v>
                </c:pt>
                <c:pt idx="6">
                  <c:v>APC</c:v>
                </c:pt>
                <c:pt idx="7">
                  <c:v>ERBB2</c:v>
                </c:pt>
                <c:pt idx="8">
                  <c:v>MYC</c:v>
                </c:pt>
                <c:pt idx="9">
                  <c:v>EGFR</c:v>
                </c:pt>
              </c:strCache>
            </c:strRef>
          </c:cat>
          <c:val>
            <c:numRef>
              <c:f>Feuil1!$B$29:$B$38</c:f>
              <c:numCache>
                <c:formatCode>0.0</c:formatCode>
                <c:ptCount val="10"/>
                <c:pt idx="0">
                  <c:v>51.2</c:v>
                </c:pt>
                <c:pt idx="1">
                  <c:v>6.1</c:v>
                </c:pt>
                <c:pt idx="2">
                  <c:v>50</c:v>
                </c:pt>
                <c:pt idx="3">
                  <c:v>12.1</c:v>
                </c:pt>
                <c:pt idx="4">
                  <c:v>12.1</c:v>
                </c:pt>
                <c:pt idx="5">
                  <c:v>2.4</c:v>
                </c:pt>
                <c:pt idx="6">
                  <c:v>36.6</c:v>
                </c:pt>
                <c:pt idx="7">
                  <c:v>3.7</c:v>
                </c:pt>
                <c:pt idx="8">
                  <c:v>6.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B9-4769-9964-884B235438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2200808"/>
        <c:axId val="2092203832"/>
      </c:barChart>
      <c:catAx>
        <c:axId val="20922008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92203832"/>
        <c:crosses val="autoZero"/>
        <c:auto val="1"/>
        <c:lblAlgn val="ctr"/>
        <c:lblOffset val="100"/>
        <c:noMultiLvlLbl val="0"/>
      </c:catAx>
      <c:valAx>
        <c:axId val="2092203832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20922008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overlay val="0"/>
    </c:title>
    <c:autoTitleDeleted val="0"/>
    <c:plotArea>
      <c:layout/>
      <c:barChart>
        <c:barDir val="col"/>
        <c:grouping val="stacked"/>
        <c:varyColors val="1"/>
        <c:ser>
          <c:idx val="0"/>
          <c:order val="0"/>
          <c:tx>
            <c:strRef>
              <c:f>Feuil1!$B$40</c:f>
              <c:strCache>
                <c:ptCount val="1"/>
                <c:pt idx="0">
                  <c:v>Breast</c:v>
                </c:pt>
              </c:strCache>
            </c:strRef>
          </c:tx>
          <c:invertIfNegative val="0"/>
          <c:cat>
            <c:strRef>
              <c:f>Feuil1!$A$41:$A$50</c:f>
              <c:strCache>
                <c:ptCount val="10"/>
                <c:pt idx="0">
                  <c:v>TP53</c:v>
                </c:pt>
                <c:pt idx="1">
                  <c:v>CDKN2A</c:v>
                </c:pt>
                <c:pt idx="2">
                  <c:v>KRAS</c:v>
                </c:pt>
                <c:pt idx="3">
                  <c:v>PTEN</c:v>
                </c:pt>
                <c:pt idx="4">
                  <c:v>PI3KCA</c:v>
                </c:pt>
                <c:pt idx="5">
                  <c:v>RB1</c:v>
                </c:pt>
                <c:pt idx="6">
                  <c:v>APC</c:v>
                </c:pt>
                <c:pt idx="7">
                  <c:v>ERBB2</c:v>
                </c:pt>
                <c:pt idx="8">
                  <c:v>MYC</c:v>
                </c:pt>
                <c:pt idx="9">
                  <c:v>EGFR</c:v>
                </c:pt>
              </c:strCache>
            </c:strRef>
          </c:cat>
          <c:val>
            <c:numRef>
              <c:f>Feuil1!$B$41:$B$50</c:f>
              <c:numCache>
                <c:formatCode>0.0</c:formatCode>
                <c:ptCount val="10"/>
                <c:pt idx="0">
                  <c:v>45</c:v>
                </c:pt>
                <c:pt idx="1">
                  <c:v>10</c:v>
                </c:pt>
                <c:pt idx="2">
                  <c:v>1.7</c:v>
                </c:pt>
                <c:pt idx="3">
                  <c:v>13.3</c:v>
                </c:pt>
                <c:pt idx="4">
                  <c:v>36.700000000000003</c:v>
                </c:pt>
                <c:pt idx="5">
                  <c:v>10</c:v>
                </c:pt>
                <c:pt idx="6">
                  <c:v>1.7</c:v>
                </c:pt>
                <c:pt idx="7">
                  <c:v>21.7</c:v>
                </c:pt>
                <c:pt idx="8">
                  <c:v>11.7</c:v>
                </c:pt>
                <c:pt idx="9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D63-4AA1-9E30-B07383DDD3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2227768"/>
        <c:axId val="2092230792"/>
      </c:barChart>
      <c:catAx>
        <c:axId val="20922277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92230792"/>
        <c:crosses val="autoZero"/>
        <c:auto val="1"/>
        <c:lblAlgn val="ctr"/>
        <c:lblOffset val="100"/>
        <c:noMultiLvlLbl val="0"/>
      </c:catAx>
      <c:valAx>
        <c:axId val="2092230792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2092227768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overlay val="0"/>
    </c:title>
    <c:autoTitleDeleted val="0"/>
    <c:plotArea>
      <c:layout/>
      <c:barChart>
        <c:barDir val="col"/>
        <c:grouping val="stacked"/>
        <c:varyColors val="1"/>
        <c:ser>
          <c:idx val="0"/>
          <c:order val="0"/>
          <c:tx>
            <c:strRef>
              <c:f>Feuil1!$B$52</c:f>
              <c:strCache>
                <c:ptCount val="1"/>
                <c:pt idx="0">
                  <c:v>Ovarian</c:v>
                </c:pt>
              </c:strCache>
            </c:strRef>
          </c:tx>
          <c:invertIfNegative val="0"/>
          <c:cat>
            <c:strRef>
              <c:f>Feuil1!$A$53:$A$62</c:f>
              <c:strCache>
                <c:ptCount val="10"/>
                <c:pt idx="0">
                  <c:v>TP53</c:v>
                </c:pt>
                <c:pt idx="1">
                  <c:v>CDKN2A</c:v>
                </c:pt>
                <c:pt idx="2">
                  <c:v>KRAS</c:v>
                </c:pt>
                <c:pt idx="3">
                  <c:v>PTEN</c:v>
                </c:pt>
                <c:pt idx="4">
                  <c:v>PI3KCA</c:v>
                </c:pt>
                <c:pt idx="5">
                  <c:v>RB1</c:v>
                </c:pt>
                <c:pt idx="6">
                  <c:v>APC</c:v>
                </c:pt>
                <c:pt idx="7">
                  <c:v>ERBB2</c:v>
                </c:pt>
                <c:pt idx="8">
                  <c:v>MYC</c:v>
                </c:pt>
                <c:pt idx="9">
                  <c:v>EGFR</c:v>
                </c:pt>
              </c:strCache>
            </c:strRef>
          </c:cat>
          <c:val>
            <c:numRef>
              <c:f>Feuil1!$B$53:$B$62</c:f>
              <c:numCache>
                <c:formatCode>0.0</c:formatCode>
                <c:ptCount val="10"/>
                <c:pt idx="0">
                  <c:v>67.2</c:v>
                </c:pt>
                <c:pt idx="1">
                  <c:v>12.1</c:v>
                </c:pt>
                <c:pt idx="2">
                  <c:v>3.4</c:v>
                </c:pt>
                <c:pt idx="3">
                  <c:v>5.2</c:v>
                </c:pt>
                <c:pt idx="4">
                  <c:v>1.7</c:v>
                </c:pt>
                <c:pt idx="5">
                  <c:v>5.2</c:v>
                </c:pt>
                <c:pt idx="6">
                  <c:v>0</c:v>
                </c:pt>
                <c:pt idx="7">
                  <c:v>5.2</c:v>
                </c:pt>
                <c:pt idx="8">
                  <c:v>13.8</c:v>
                </c:pt>
                <c:pt idx="9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33-4D84-B91A-EA48C5CECA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2254728"/>
        <c:axId val="2092257752"/>
      </c:barChart>
      <c:catAx>
        <c:axId val="20922547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92257752"/>
        <c:crosses val="autoZero"/>
        <c:auto val="1"/>
        <c:lblAlgn val="ctr"/>
        <c:lblOffset val="100"/>
        <c:noMultiLvlLbl val="0"/>
      </c:catAx>
      <c:valAx>
        <c:axId val="2092257752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20922547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overlay val="0"/>
    </c:title>
    <c:autoTitleDeleted val="0"/>
    <c:plotArea>
      <c:layout/>
      <c:barChart>
        <c:barDir val="col"/>
        <c:grouping val="stacked"/>
        <c:varyColors val="1"/>
        <c:ser>
          <c:idx val="0"/>
          <c:order val="0"/>
          <c:tx>
            <c:strRef>
              <c:f>Feuil1!$B$64</c:f>
              <c:strCache>
                <c:ptCount val="1"/>
                <c:pt idx="0">
                  <c:v>Sarcoma</c:v>
                </c:pt>
              </c:strCache>
            </c:strRef>
          </c:tx>
          <c:invertIfNegative val="0"/>
          <c:cat>
            <c:strRef>
              <c:f>Feuil1!$A$65:$A$74</c:f>
              <c:strCache>
                <c:ptCount val="10"/>
                <c:pt idx="0">
                  <c:v>TP53</c:v>
                </c:pt>
                <c:pt idx="1">
                  <c:v>CDKN2A</c:v>
                </c:pt>
                <c:pt idx="2">
                  <c:v>KRAS</c:v>
                </c:pt>
                <c:pt idx="3">
                  <c:v>PTEN</c:v>
                </c:pt>
                <c:pt idx="4">
                  <c:v>PI3KCA</c:v>
                </c:pt>
                <c:pt idx="5">
                  <c:v>RB1</c:v>
                </c:pt>
                <c:pt idx="6">
                  <c:v>APC</c:v>
                </c:pt>
                <c:pt idx="7">
                  <c:v>ERBB2</c:v>
                </c:pt>
                <c:pt idx="8">
                  <c:v>MYC</c:v>
                </c:pt>
                <c:pt idx="9">
                  <c:v>EGFR</c:v>
                </c:pt>
              </c:strCache>
            </c:strRef>
          </c:cat>
          <c:val>
            <c:numRef>
              <c:f>Feuil1!$B$65:$B$74</c:f>
              <c:numCache>
                <c:formatCode>0.0</c:formatCode>
                <c:ptCount val="10"/>
                <c:pt idx="0">
                  <c:v>37.9</c:v>
                </c:pt>
                <c:pt idx="1">
                  <c:v>27.6</c:v>
                </c:pt>
                <c:pt idx="2">
                  <c:v>3.4</c:v>
                </c:pt>
                <c:pt idx="3">
                  <c:v>17.2</c:v>
                </c:pt>
                <c:pt idx="4">
                  <c:v>0</c:v>
                </c:pt>
                <c:pt idx="5">
                  <c:v>34.5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CE-4537-AC99-C1A253ABF6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2281688"/>
        <c:axId val="2092284712"/>
      </c:barChart>
      <c:catAx>
        <c:axId val="20922816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92284712"/>
        <c:crosses val="autoZero"/>
        <c:auto val="1"/>
        <c:lblAlgn val="ctr"/>
        <c:lblOffset val="100"/>
        <c:noMultiLvlLbl val="0"/>
      </c:catAx>
      <c:valAx>
        <c:axId val="2092284712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2092281688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overlay val="0"/>
    </c:title>
    <c:autoTitleDeleted val="0"/>
    <c:plotArea>
      <c:layout/>
      <c:barChart>
        <c:barDir val="col"/>
        <c:grouping val="stacked"/>
        <c:varyColors val="1"/>
        <c:ser>
          <c:idx val="0"/>
          <c:order val="0"/>
          <c:tx>
            <c:strRef>
              <c:f>Feuil1!$B$76</c:f>
              <c:strCache>
                <c:ptCount val="1"/>
                <c:pt idx="0">
                  <c:v>Pancreas</c:v>
                </c:pt>
              </c:strCache>
            </c:strRef>
          </c:tx>
          <c:invertIfNegative val="0"/>
          <c:cat>
            <c:strRef>
              <c:f>Feuil1!$A$77:$A$86</c:f>
              <c:strCache>
                <c:ptCount val="10"/>
                <c:pt idx="0">
                  <c:v>TP53</c:v>
                </c:pt>
                <c:pt idx="1">
                  <c:v>CDKN2A</c:v>
                </c:pt>
                <c:pt idx="2">
                  <c:v>KRAS</c:v>
                </c:pt>
                <c:pt idx="3">
                  <c:v>PTEN</c:v>
                </c:pt>
                <c:pt idx="4">
                  <c:v>PI3KCA</c:v>
                </c:pt>
                <c:pt idx="5">
                  <c:v>RB1</c:v>
                </c:pt>
                <c:pt idx="6">
                  <c:v>APC</c:v>
                </c:pt>
                <c:pt idx="7">
                  <c:v>ERBB2</c:v>
                </c:pt>
                <c:pt idx="8">
                  <c:v>MYC</c:v>
                </c:pt>
                <c:pt idx="9">
                  <c:v>EGFR</c:v>
                </c:pt>
              </c:strCache>
            </c:strRef>
          </c:cat>
          <c:val>
            <c:numRef>
              <c:f>Feuil1!$B$77:$B$86</c:f>
              <c:numCache>
                <c:formatCode>0.0</c:formatCode>
                <c:ptCount val="10"/>
                <c:pt idx="0">
                  <c:v>27</c:v>
                </c:pt>
                <c:pt idx="1">
                  <c:v>29.7</c:v>
                </c:pt>
                <c:pt idx="2">
                  <c:v>64.900000000000006</c:v>
                </c:pt>
                <c:pt idx="3">
                  <c:v>0</c:v>
                </c:pt>
                <c:pt idx="4">
                  <c:v>0</c:v>
                </c:pt>
                <c:pt idx="5">
                  <c:v>2.7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45-4433-B9B0-8C6CFE15C6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2308648"/>
        <c:axId val="2092311672"/>
      </c:barChart>
      <c:catAx>
        <c:axId val="20923086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92311672"/>
        <c:crosses val="autoZero"/>
        <c:auto val="1"/>
        <c:lblAlgn val="ctr"/>
        <c:lblOffset val="100"/>
        <c:noMultiLvlLbl val="0"/>
      </c:catAx>
      <c:valAx>
        <c:axId val="2092311672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20923086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overlay val="0"/>
    </c:title>
    <c:autoTitleDeleted val="0"/>
    <c:plotArea>
      <c:layout/>
      <c:barChart>
        <c:barDir val="col"/>
        <c:grouping val="stacked"/>
        <c:varyColors val="1"/>
        <c:ser>
          <c:idx val="0"/>
          <c:order val="0"/>
          <c:tx>
            <c:strRef>
              <c:f>Feuil1!$B$101</c:f>
              <c:strCache>
                <c:ptCount val="1"/>
                <c:pt idx="0">
                  <c:v>Endometrial</c:v>
                </c:pt>
              </c:strCache>
            </c:strRef>
          </c:tx>
          <c:invertIfNegative val="0"/>
          <c:cat>
            <c:strRef>
              <c:f>Feuil1!$A$102:$A$111</c:f>
              <c:strCache>
                <c:ptCount val="10"/>
                <c:pt idx="0">
                  <c:v>TP53</c:v>
                </c:pt>
                <c:pt idx="1">
                  <c:v>CDKN2A</c:v>
                </c:pt>
                <c:pt idx="2">
                  <c:v>KRAS</c:v>
                </c:pt>
                <c:pt idx="3">
                  <c:v>PTEN</c:v>
                </c:pt>
                <c:pt idx="4">
                  <c:v>PI3KCA</c:v>
                </c:pt>
                <c:pt idx="5">
                  <c:v>RB1</c:v>
                </c:pt>
                <c:pt idx="6">
                  <c:v>APC</c:v>
                </c:pt>
                <c:pt idx="7">
                  <c:v>ERBB2</c:v>
                </c:pt>
                <c:pt idx="8">
                  <c:v>MYC</c:v>
                </c:pt>
                <c:pt idx="9">
                  <c:v>EGFR</c:v>
                </c:pt>
              </c:strCache>
            </c:strRef>
          </c:cat>
          <c:val>
            <c:numRef>
              <c:f>Feuil1!$B$102:$B$111</c:f>
              <c:numCache>
                <c:formatCode>0.0</c:formatCode>
                <c:ptCount val="10"/>
                <c:pt idx="0">
                  <c:v>48.6</c:v>
                </c:pt>
                <c:pt idx="1">
                  <c:v>20</c:v>
                </c:pt>
                <c:pt idx="2">
                  <c:v>5.7</c:v>
                </c:pt>
                <c:pt idx="3">
                  <c:v>34.200000000000003</c:v>
                </c:pt>
                <c:pt idx="4">
                  <c:v>22.9</c:v>
                </c:pt>
                <c:pt idx="5">
                  <c:v>14.3</c:v>
                </c:pt>
                <c:pt idx="6">
                  <c:v>0</c:v>
                </c:pt>
                <c:pt idx="7">
                  <c:v>8.6</c:v>
                </c:pt>
                <c:pt idx="8">
                  <c:v>5.7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0E0-4C78-A87E-0B48DA304F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2335640"/>
        <c:axId val="2092338664"/>
      </c:barChart>
      <c:catAx>
        <c:axId val="20923356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92338664"/>
        <c:crosses val="autoZero"/>
        <c:auto val="1"/>
        <c:lblAlgn val="ctr"/>
        <c:lblOffset val="100"/>
        <c:noMultiLvlLbl val="0"/>
      </c:catAx>
      <c:valAx>
        <c:axId val="2092338664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20923356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overlay val="0"/>
    </c:title>
    <c:autoTitleDeleted val="0"/>
    <c:plotArea>
      <c:layout/>
      <c:barChart>
        <c:barDir val="col"/>
        <c:grouping val="stacked"/>
        <c:varyColors val="1"/>
        <c:ser>
          <c:idx val="0"/>
          <c:order val="0"/>
          <c:tx>
            <c:strRef>
              <c:f>Feuil1!$B$114</c:f>
              <c:strCache>
                <c:ptCount val="1"/>
                <c:pt idx="0">
                  <c:v>Urothelial</c:v>
                </c:pt>
              </c:strCache>
            </c:strRef>
          </c:tx>
          <c:invertIfNegative val="0"/>
          <c:cat>
            <c:strRef>
              <c:f>Feuil1!$A$115:$A$124</c:f>
              <c:strCache>
                <c:ptCount val="10"/>
                <c:pt idx="0">
                  <c:v>TP53</c:v>
                </c:pt>
                <c:pt idx="1">
                  <c:v>CDKN2A</c:v>
                </c:pt>
                <c:pt idx="2">
                  <c:v>KRAS</c:v>
                </c:pt>
                <c:pt idx="3">
                  <c:v>PTEN</c:v>
                </c:pt>
                <c:pt idx="4">
                  <c:v>PI3KCA</c:v>
                </c:pt>
                <c:pt idx="5">
                  <c:v>RB1</c:v>
                </c:pt>
                <c:pt idx="6">
                  <c:v>APC</c:v>
                </c:pt>
                <c:pt idx="7">
                  <c:v>ERBB2</c:v>
                </c:pt>
                <c:pt idx="8">
                  <c:v>MYC</c:v>
                </c:pt>
                <c:pt idx="9">
                  <c:v>EGFR</c:v>
                </c:pt>
              </c:strCache>
            </c:strRef>
          </c:cat>
          <c:val>
            <c:numRef>
              <c:f>Feuil1!$B$115:$B$124</c:f>
              <c:numCache>
                <c:formatCode>0.0</c:formatCode>
                <c:ptCount val="10"/>
                <c:pt idx="0">
                  <c:v>50</c:v>
                </c:pt>
                <c:pt idx="1">
                  <c:v>32.1</c:v>
                </c:pt>
                <c:pt idx="2">
                  <c:v>0</c:v>
                </c:pt>
                <c:pt idx="3">
                  <c:v>14.3</c:v>
                </c:pt>
                <c:pt idx="4">
                  <c:v>25</c:v>
                </c:pt>
                <c:pt idx="5">
                  <c:v>7.1</c:v>
                </c:pt>
                <c:pt idx="6">
                  <c:v>0</c:v>
                </c:pt>
                <c:pt idx="7">
                  <c:v>10.7</c:v>
                </c:pt>
                <c:pt idx="8">
                  <c:v>7.1</c:v>
                </c:pt>
                <c:pt idx="9">
                  <c:v>7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79-425C-A555-64F64CE68B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2363160"/>
        <c:axId val="2092366184"/>
      </c:barChart>
      <c:catAx>
        <c:axId val="20923631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92366184"/>
        <c:crosses val="autoZero"/>
        <c:auto val="1"/>
        <c:lblAlgn val="ctr"/>
        <c:lblOffset val="100"/>
        <c:noMultiLvlLbl val="0"/>
      </c:catAx>
      <c:valAx>
        <c:axId val="2092366184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20923631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overlay val="0"/>
    </c:title>
    <c:autoTitleDeleted val="0"/>
    <c:plotArea>
      <c:layout/>
      <c:barChart>
        <c:barDir val="col"/>
        <c:grouping val="stacked"/>
        <c:varyColors val="1"/>
        <c:ser>
          <c:idx val="0"/>
          <c:order val="0"/>
          <c:tx>
            <c:strRef>
              <c:f>Feuil1!$B$127</c:f>
              <c:strCache>
                <c:ptCount val="1"/>
                <c:pt idx="0">
                  <c:v>Head and Neck</c:v>
                </c:pt>
              </c:strCache>
            </c:strRef>
          </c:tx>
          <c:invertIfNegative val="0"/>
          <c:cat>
            <c:strRef>
              <c:f>Feuil1!$A$128:$A$137</c:f>
              <c:strCache>
                <c:ptCount val="10"/>
                <c:pt idx="0">
                  <c:v>TP53</c:v>
                </c:pt>
                <c:pt idx="1">
                  <c:v>CDKN2A</c:v>
                </c:pt>
                <c:pt idx="2">
                  <c:v>KRAS</c:v>
                </c:pt>
                <c:pt idx="3">
                  <c:v>PTEN</c:v>
                </c:pt>
                <c:pt idx="4">
                  <c:v>PI3KCA</c:v>
                </c:pt>
                <c:pt idx="5">
                  <c:v>RB1</c:v>
                </c:pt>
                <c:pt idx="6">
                  <c:v>APC</c:v>
                </c:pt>
                <c:pt idx="7">
                  <c:v>ERBB2</c:v>
                </c:pt>
                <c:pt idx="8">
                  <c:v>MYC</c:v>
                </c:pt>
                <c:pt idx="9">
                  <c:v>EGFR</c:v>
                </c:pt>
              </c:strCache>
            </c:strRef>
          </c:cat>
          <c:val>
            <c:numRef>
              <c:f>Feuil1!$B$128:$B$137</c:f>
              <c:numCache>
                <c:formatCode>0.0</c:formatCode>
                <c:ptCount val="10"/>
                <c:pt idx="0">
                  <c:v>31.6</c:v>
                </c:pt>
                <c:pt idx="1">
                  <c:v>31.6</c:v>
                </c:pt>
                <c:pt idx="2">
                  <c:v>0</c:v>
                </c:pt>
                <c:pt idx="3">
                  <c:v>10.5</c:v>
                </c:pt>
                <c:pt idx="4">
                  <c:v>0</c:v>
                </c:pt>
                <c:pt idx="5">
                  <c:v>10.5</c:v>
                </c:pt>
                <c:pt idx="6">
                  <c:v>0</c:v>
                </c:pt>
                <c:pt idx="7">
                  <c:v>0</c:v>
                </c:pt>
                <c:pt idx="8">
                  <c:v>5.3</c:v>
                </c:pt>
                <c:pt idx="9">
                  <c:v>1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13D-465C-8094-124744BA27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3209096"/>
        <c:axId val="2093212168"/>
      </c:barChart>
      <c:catAx>
        <c:axId val="20932090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93212168"/>
        <c:crosses val="autoZero"/>
        <c:auto val="1"/>
        <c:lblAlgn val="ctr"/>
        <c:lblOffset val="100"/>
        <c:noMultiLvlLbl val="0"/>
      </c:catAx>
      <c:valAx>
        <c:axId val="2093212168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20932090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1F141-1A9F-FE43-BD31-AC59002A0609}" type="datetimeFigureOut">
              <a:rPr lang="fr-FR" smtClean="0"/>
              <a:t>25/10/2016</a:t>
            </a:fld>
            <a:endParaRPr lang="fr-FR" dirty="0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7261-0301-AB4C-B246-177A50B4337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814194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1F141-1A9F-FE43-BD31-AC59002A0609}" type="datetimeFigureOut">
              <a:rPr lang="fr-FR" smtClean="0"/>
              <a:t>25/10/2016</a:t>
            </a:fld>
            <a:endParaRPr lang="fr-FR" dirty="0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7261-0301-AB4C-B246-177A50B4337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623177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1F141-1A9F-FE43-BD31-AC59002A0609}" type="datetimeFigureOut">
              <a:rPr lang="fr-FR" smtClean="0"/>
              <a:t>25/10/2016</a:t>
            </a:fld>
            <a:endParaRPr lang="fr-FR" dirty="0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7261-0301-AB4C-B246-177A50B4337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09621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1F141-1A9F-FE43-BD31-AC59002A0609}" type="datetimeFigureOut">
              <a:rPr lang="fr-FR" smtClean="0"/>
              <a:t>25/10/2016</a:t>
            </a:fld>
            <a:endParaRPr lang="fr-FR" dirty="0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7261-0301-AB4C-B246-177A50B4337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24117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1F141-1A9F-FE43-BD31-AC59002A0609}" type="datetimeFigureOut">
              <a:rPr lang="fr-FR" smtClean="0"/>
              <a:t>25/10/2016</a:t>
            </a:fld>
            <a:endParaRPr lang="fr-FR" dirty="0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7261-0301-AB4C-B246-177A50B4337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291898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1F141-1A9F-FE43-BD31-AC59002A0609}" type="datetimeFigureOut">
              <a:rPr lang="fr-FR" smtClean="0"/>
              <a:t>25/10/2016</a:t>
            </a:fld>
            <a:endParaRPr lang="fr-FR" dirty="0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7261-0301-AB4C-B246-177A50B4337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403602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1F141-1A9F-FE43-BD31-AC59002A0609}" type="datetimeFigureOut">
              <a:rPr lang="fr-FR" smtClean="0"/>
              <a:t>25/10/2016</a:t>
            </a:fld>
            <a:endParaRPr lang="fr-FR" dirty="0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7261-0301-AB4C-B246-177A50B4337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548982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1F141-1A9F-FE43-BD31-AC59002A0609}" type="datetimeFigureOut">
              <a:rPr lang="fr-FR" smtClean="0"/>
              <a:t>25/10/2016</a:t>
            </a:fld>
            <a:endParaRPr lang="fr-FR" dirty="0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7261-0301-AB4C-B246-177A50B4337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658548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1F141-1A9F-FE43-BD31-AC59002A0609}" type="datetimeFigureOut">
              <a:rPr lang="fr-FR" smtClean="0"/>
              <a:t>25/10/2016</a:t>
            </a:fld>
            <a:endParaRPr lang="fr-FR" dirty="0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7261-0301-AB4C-B246-177A50B4337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048129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1F141-1A9F-FE43-BD31-AC59002A0609}" type="datetimeFigureOut">
              <a:rPr lang="fr-FR" smtClean="0"/>
              <a:t>25/10/2016</a:t>
            </a:fld>
            <a:endParaRPr lang="fr-FR" dirty="0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7261-0301-AB4C-B246-177A50B4337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9248609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 dirty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1F141-1A9F-FE43-BD31-AC59002A0609}" type="datetimeFigureOut">
              <a:rPr lang="fr-FR" smtClean="0"/>
              <a:t>25/10/2016</a:t>
            </a:fld>
            <a:endParaRPr lang="fr-FR" dirty="0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7261-0301-AB4C-B246-177A50B4337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51487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31F141-1A9F-FE43-BD31-AC59002A0609}" type="datetimeFigureOut">
              <a:rPr lang="fr-FR" smtClean="0"/>
              <a:t>25/10/2016</a:t>
            </a:fld>
            <a:endParaRPr lang="fr-FR" dirty="0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B37261-0301-AB4C-B246-177A50B4337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084396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/>
          <p:nvPr>
            <p:extLst>
              <p:ext uri="{D42A27DB-BD31-4B8C-83A1-F6EECF244321}">
                <p14:modId xmlns:p14="http://schemas.microsoft.com/office/powerpoint/2010/main" val="1636892192"/>
              </p:ext>
            </p:extLst>
          </p:nvPr>
        </p:nvGraphicFramePr>
        <p:xfrm>
          <a:off x="0" y="30362"/>
          <a:ext cx="2739556" cy="19363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5692623"/>
              </p:ext>
            </p:extLst>
          </p:nvPr>
        </p:nvGraphicFramePr>
        <p:xfrm>
          <a:off x="2622929" y="30362"/>
          <a:ext cx="2747248" cy="19463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222375"/>
              </p:ext>
            </p:extLst>
          </p:nvPr>
        </p:nvGraphicFramePr>
        <p:xfrm>
          <a:off x="5240590" y="38875"/>
          <a:ext cx="2975242" cy="1927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0755450"/>
              </p:ext>
            </p:extLst>
          </p:nvPr>
        </p:nvGraphicFramePr>
        <p:xfrm>
          <a:off x="0" y="1694578"/>
          <a:ext cx="2739555" cy="1817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Graphique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7701093"/>
              </p:ext>
            </p:extLst>
          </p:nvPr>
        </p:nvGraphicFramePr>
        <p:xfrm>
          <a:off x="2622523" y="1694578"/>
          <a:ext cx="2747654" cy="1817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Graphique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3308836"/>
              </p:ext>
            </p:extLst>
          </p:nvPr>
        </p:nvGraphicFramePr>
        <p:xfrm>
          <a:off x="5240589" y="1694578"/>
          <a:ext cx="2975243" cy="18069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Graphique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78409692"/>
              </p:ext>
            </p:extLst>
          </p:nvPr>
        </p:nvGraphicFramePr>
        <p:xfrm>
          <a:off x="0" y="3255367"/>
          <a:ext cx="2739554" cy="18630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" name="Graphique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9502623"/>
              </p:ext>
            </p:extLst>
          </p:nvPr>
        </p:nvGraphicFramePr>
        <p:xfrm>
          <a:off x="2524525" y="3218766"/>
          <a:ext cx="2716066" cy="1960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3" name="Graphique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8178459"/>
              </p:ext>
            </p:extLst>
          </p:nvPr>
        </p:nvGraphicFramePr>
        <p:xfrm>
          <a:off x="5222368" y="3218766"/>
          <a:ext cx="2773166" cy="18996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4" name="Graphique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9900268"/>
              </p:ext>
            </p:extLst>
          </p:nvPr>
        </p:nvGraphicFramePr>
        <p:xfrm>
          <a:off x="0" y="4957069"/>
          <a:ext cx="2739553" cy="15996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2" name="ZoneTexte 1"/>
          <p:cNvSpPr txBox="1"/>
          <p:nvPr/>
        </p:nvSpPr>
        <p:spPr>
          <a:xfrm>
            <a:off x="3252640" y="5520091"/>
            <a:ext cx="50668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upplemental Figure 1: Molecular profiles of the 10 most frequent </a:t>
            </a:r>
            <a:r>
              <a:rPr lang="en-US" sz="1400" dirty="0" err="1"/>
              <a:t>tumour</a:t>
            </a:r>
            <a:r>
              <a:rPr lang="en-US" sz="1400" dirty="0"/>
              <a:t> types</a:t>
            </a:r>
          </a:p>
        </p:txBody>
      </p:sp>
    </p:spTree>
    <p:extLst>
      <p:ext uri="{BB962C8B-B14F-4D97-AF65-F5344CB8AC3E}">
        <p14:creationId xmlns:p14="http://schemas.microsoft.com/office/powerpoint/2010/main" val="428664780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</TotalTime>
  <Words>25</Words>
  <Application>Microsoft Office PowerPoint</Application>
  <PresentationFormat>Affichage à l'écran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ophie</dc:creator>
  <cp:lastModifiedBy>Antoine Italiano</cp:lastModifiedBy>
  <cp:revision>10</cp:revision>
  <dcterms:created xsi:type="dcterms:W3CDTF">2016-10-02T17:50:50Z</dcterms:created>
  <dcterms:modified xsi:type="dcterms:W3CDTF">2016-10-25T21:30:38Z</dcterms:modified>
</cp:coreProperties>
</file>